
<file path=[Content_Types].xml><?xml version="1.0" encoding="utf-8"?>
<Types xmlns="http://schemas.openxmlformats.org/package/2006/content-types">
  <Default Extension="gif" ContentType="image/gi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ifq5DNNEQda7FuAIazNbEYwfapK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9"/>
  </p:normalViewPr>
  <p:slideViewPr>
    <p:cSldViewPr snapToGrid="0">
      <p:cViewPr varScale="1">
        <p:scale>
          <a:sx n="102" d="100"/>
          <a:sy n="102" d="100"/>
        </p:scale>
        <p:origin x="9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12" Type="http://customschemas.google.com/relationships/presentationmetadata" Target="metadata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5" Type="http://schemas.openxmlformats.org/officeDocument/2006/relationships/theme" Target="theme/theme1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86434803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g28dcadfad99_1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223" name="Google Shape;223;g28dcadfad99_1_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24" name="Google Shape;224;g28dcadfad99_1_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925857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9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0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1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3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3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6" name="Google Shape;226;g28dcadfad99_1_0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3092425" y="1167825"/>
            <a:ext cx="5334000" cy="4000500"/>
          </a:xfrm>
          <a:prstGeom prst="rect">
            <a:avLst/>
          </a:prstGeom>
          <a:noFill/>
          <a:ln>
            <a:noFill/>
          </a:ln>
        </p:spPr>
      </p:pic>
      <p:sp>
        <p:nvSpPr>
          <p:cNvPr id="227" name="Google Shape;227;g28dcadfad99_1_0"/>
          <p:cNvSpPr txBox="1"/>
          <p:nvPr/>
        </p:nvSpPr>
        <p:spPr>
          <a:xfrm>
            <a:off x="2521500" y="5834800"/>
            <a:ext cx="73818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 1: Segmented B-Mode image volume overlaid on CT volume to show that features and overall geometry register well. </a:t>
            </a:r>
            <a:endParaRPr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6</TotalTime>
  <Words>23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EIL</dc:creator>
  <cp:lastModifiedBy>Singh, Aparna</cp:lastModifiedBy>
  <cp:revision>10</cp:revision>
  <dcterms:created xsi:type="dcterms:W3CDTF">2022-12-12T16:58:28Z</dcterms:created>
  <dcterms:modified xsi:type="dcterms:W3CDTF">2023-12-17T12:51:13Z</dcterms:modified>
</cp:coreProperties>
</file>